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748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2676" y="12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7B179-94D7-48C1-B003-FE4DA159E964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117B1-B38B-4794-95F9-E0919D292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620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7B179-94D7-48C1-B003-FE4DA159E964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117B1-B38B-4794-95F9-E0919D292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235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7B179-94D7-48C1-B003-FE4DA159E964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117B1-B38B-4794-95F9-E0919D292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244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7B179-94D7-48C1-B003-FE4DA159E964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117B1-B38B-4794-95F9-E0919D292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50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7B179-94D7-48C1-B003-FE4DA159E964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117B1-B38B-4794-95F9-E0919D292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386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7B179-94D7-48C1-B003-FE4DA159E964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117B1-B38B-4794-95F9-E0919D292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2110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7B179-94D7-48C1-B003-FE4DA159E964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117B1-B38B-4794-95F9-E0919D292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152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7B179-94D7-48C1-B003-FE4DA159E964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117B1-B38B-4794-95F9-E0919D292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253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7B179-94D7-48C1-B003-FE4DA159E964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117B1-B38B-4794-95F9-E0919D292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122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7B179-94D7-48C1-B003-FE4DA159E964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117B1-B38B-4794-95F9-E0919D292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188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7B179-94D7-48C1-B003-FE4DA159E964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117B1-B38B-4794-95F9-E0919D292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169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C7B179-94D7-48C1-B003-FE4DA159E964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C117B1-B38B-4794-95F9-E0919D292F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533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809476" y="736614"/>
            <a:ext cx="11913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ositive ion mod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871834" y="736615"/>
            <a:ext cx="12474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egative ion mod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20494" y="1158765"/>
            <a:ext cx="9861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patotoxicity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ute phas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250" y="1933903"/>
            <a:ext cx="1183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patotoxicity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covered phas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65532" y="2650436"/>
            <a:ext cx="89159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ixed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ute phas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0" y="3317998"/>
            <a:ext cx="1183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ixed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covered phas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65532" y="4096003"/>
            <a:ext cx="89159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olestatic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ute phas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0" y="4794301"/>
            <a:ext cx="1183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olestatic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covered phas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20493" y="6517391"/>
            <a:ext cx="66586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The exemplar LC/MS traces of plasma lipid profiles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4917" y="982836"/>
            <a:ext cx="5411703" cy="5264284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02589" y="5615543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althy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6934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37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itok2</dc:creator>
  <cp:lastModifiedBy>saitok2</cp:lastModifiedBy>
  <cp:revision>3</cp:revision>
  <dcterms:created xsi:type="dcterms:W3CDTF">2020-07-27T06:02:00Z</dcterms:created>
  <dcterms:modified xsi:type="dcterms:W3CDTF">2020-08-18T03:06:01Z</dcterms:modified>
</cp:coreProperties>
</file>